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06" autoAdjust="0"/>
  </p:normalViewPr>
  <p:slideViewPr>
    <p:cSldViewPr>
      <p:cViewPr varScale="1">
        <p:scale>
          <a:sx n="46" d="100"/>
          <a:sy n="46" d="100"/>
        </p:scale>
        <p:origin x="2112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テキスト ボックス 1"/>
          <p:cNvSpPr txBox="1"/>
          <p:nvPr/>
        </p:nvSpPr>
        <p:spPr>
          <a:xfrm>
            <a:off x="116632" y="35496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V 3A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50255" y="566020"/>
            <a:ext cx="2644056" cy="1762705"/>
            <a:chOff x="170440" y="2806475"/>
            <a:chExt cx="2403687" cy="1602459"/>
          </a:xfrm>
        </p:grpSpPr>
        <p:pic>
          <p:nvPicPr>
            <p:cNvPr id="4098" name="Picture 2" descr="C:\Users\ImageQuant\Desktop\Sonomi\Fstl1\4. MI\Heart\1-21-2015 Heart2 MI1W\p-smad 2\p-smad2 high 20150131_1242_1_8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0440" y="2806475"/>
              <a:ext cx="2403687" cy="16024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1" name="正方形/長方形 22"/>
            <p:cNvSpPr/>
            <p:nvPr/>
          </p:nvSpPr>
          <p:spPr>
            <a:xfrm>
              <a:off x="717167" y="3237600"/>
              <a:ext cx="894226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テキスト ボックス 23"/>
            <p:cNvSpPr txBox="1"/>
            <p:nvPr/>
          </p:nvSpPr>
          <p:spPr>
            <a:xfrm>
              <a:off x="436540" y="2968428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Smad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2945185" y="572763"/>
            <a:ext cx="2644055" cy="1762705"/>
            <a:chOff x="2553091" y="2809295"/>
            <a:chExt cx="2644055" cy="1762705"/>
          </a:xfrm>
        </p:grpSpPr>
        <p:pic>
          <p:nvPicPr>
            <p:cNvPr id="4099" name="Picture 3" descr="C:\Users\ImageQuant\Desktop\Sonomi\Fstl1\4. MI\Heart\1-21-2015 Heart2 MI1W\smad2\smad2 use this standard 20150203_1228_6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3091" y="2809295"/>
              <a:ext cx="2644055" cy="17627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7" name="正方形/長方形 22"/>
            <p:cNvSpPr/>
            <p:nvPr/>
          </p:nvSpPr>
          <p:spPr>
            <a:xfrm>
              <a:off x="3051269" y="3332711"/>
              <a:ext cx="983649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テキスト ボックス 23"/>
            <p:cNvSpPr txBox="1"/>
            <p:nvPr/>
          </p:nvSpPr>
          <p:spPr>
            <a:xfrm>
              <a:off x="2771975" y="3063539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d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116632" y="2340709"/>
            <a:ext cx="2908460" cy="1938975"/>
            <a:chOff x="116632" y="4577241"/>
            <a:chExt cx="2908460" cy="1938975"/>
          </a:xfrm>
        </p:grpSpPr>
        <p:pic>
          <p:nvPicPr>
            <p:cNvPr id="4100" name="Picture 4" descr="C:\Users\ImageQuant\Desktop\Sonomi\Fstl1\4. MI\Heart\1-21-2015 Heart2 MI1W\p-smad3\20150205_1521_23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6632" y="4577241"/>
              <a:ext cx="2908460" cy="19389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1" name="正方形/長方形 22"/>
            <p:cNvSpPr/>
            <p:nvPr/>
          </p:nvSpPr>
          <p:spPr>
            <a:xfrm>
              <a:off x="715601" y="5273220"/>
              <a:ext cx="1082014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テキスト ボックス 23"/>
            <p:cNvSpPr txBox="1"/>
            <p:nvPr/>
          </p:nvSpPr>
          <p:spPr>
            <a:xfrm>
              <a:off x="437775" y="4716016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Smad3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2824796" y="2344993"/>
            <a:ext cx="2908460" cy="1938975"/>
            <a:chOff x="2824796" y="4581525"/>
            <a:chExt cx="2908460" cy="1938975"/>
          </a:xfrm>
        </p:grpSpPr>
        <p:pic>
          <p:nvPicPr>
            <p:cNvPr id="4101" name="Picture 5" descr="C:\Users\ImageQuant\Desktop\Sonomi\Fstl1\4. MI\Heart\1-21-2015 Heart2 MI1W\smad-3\smad3 20150210_1825_7_13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4796" y="4581525"/>
              <a:ext cx="2908460" cy="19389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5" name="正方形/長方形 22"/>
            <p:cNvSpPr/>
            <p:nvPr/>
          </p:nvSpPr>
          <p:spPr>
            <a:xfrm>
              <a:off x="3480064" y="5282745"/>
              <a:ext cx="1082014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テキスト ボックス 23"/>
            <p:cNvSpPr txBox="1"/>
            <p:nvPr/>
          </p:nvSpPr>
          <p:spPr>
            <a:xfrm>
              <a:off x="3202238" y="4725541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d3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Group 8"/>
          <p:cNvGrpSpPr/>
          <p:nvPr/>
        </p:nvGrpSpPr>
        <p:grpSpPr>
          <a:xfrm>
            <a:off x="4409690" y="6372200"/>
            <a:ext cx="2403686" cy="1602459"/>
            <a:chOff x="278004" y="4255393"/>
            <a:chExt cx="2908460" cy="1938975"/>
          </a:xfrm>
        </p:grpSpPr>
        <p:pic>
          <p:nvPicPr>
            <p:cNvPr id="30" name="Picture 6" descr="C:\Users\ImageQuant\Desktop\Sonomi\Fstl1\2. NRFB\NRFB rec Fstl1 8-12-2014\NRFB1 tubulin\tubulin 20140918_1418_2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8004" y="4255393"/>
              <a:ext cx="2908460" cy="19389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3" name="正方形/長方形 22"/>
            <p:cNvSpPr/>
            <p:nvPr/>
          </p:nvSpPr>
          <p:spPr>
            <a:xfrm>
              <a:off x="2041898" y="4994540"/>
              <a:ext cx="739030" cy="183184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テキスト ボックス 23"/>
            <p:cNvSpPr txBox="1"/>
            <p:nvPr/>
          </p:nvSpPr>
          <p:spPr>
            <a:xfrm>
              <a:off x="2058815" y="4644008"/>
              <a:ext cx="7239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oup 2"/>
          <p:cNvGrpSpPr/>
          <p:nvPr/>
        </p:nvGrpSpPr>
        <p:grpSpPr>
          <a:xfrm>
            <a:off x="2492896" y="4775841"/>
            <a:ext cx="2403686" cy="1602459"/>
            <a:chOff x="3118177" y="251520"/>
            <a:chExt cx="3519237" cy="2346159"/>
          </a:xfrm>
        </p:grpSpPr>
        <p:pic>
          <p:nvPicPr>
            <p:cNvPr id="36" name="Picture 2" descr="C:\Users\ImageQuant\Desktop\Sonomi\Fstl1\2. NRFB\NRFB rec Fstl1 8-12-2014\NRFB1 t-smad2\t-smad2 20140815_1453_5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18177" y="251520"/>
              <a:ext cx="3519237" cy="23461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正方形/長方形 22"/>
            <p:cNvSpPr/>
            <p:nvPr/>
          </p:nvSpPr>
          <p:spPr>
            <a:xfrm>
              <a:off x="5063300" y="1000365"/>
              <a:ext cx="894226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テキスト ボックス 23"/>
            <p:cNvSpPr txBox="1"/>
            <p:nvPr/>
          </p:nvSpPr>
          <p:spPr>
            <a:xfrm>
              <a:off x="5012469" y="323528"/>
              <a:ext cx="6487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d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3" name="Group 4"/>
          <p:cNvGrpSpPr/>
          <p:nvPr/>
        </p:nvGrpSpPr>
        <p:grpSpPr>
          <a:xfrm>
            <a:off x="188640" y="4769741"/>
            <a:ext cx="2403686" cy="1602459"/>
            <a:chOff x="53779" y="275903"/>
            <a:chExt cx="3519237" cy="2346159"/>
          </a:xfrm>
        </p:grpSpPr>
        <p:pic>
          <p:nvPicPr>
            <p:cNvPr id="44" name="Picture 3" descr="C:\Users\ImageQuant\Desktop\Sonomi\Fstl1\2. NRFB\NRFB rec Fstl1 8-12-2014\NRFB1 p-smad2\p-smad2 20140812_2124_1_5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779" y="275903"/>
              <a:ext cx="3519237" cy="23461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7" name="正方形/長方形 22"/>
            <p:cNvSpPr/>
            <p:nvPr/>
          </p:nvSpPr>
          <p:spPr>
            <a:xfrm>
              <a:off x="1992046" y="1057030"/>
              <a:ext cx="894226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テキスト ボックス 23"/>
            <p:cNvSpPr txBox="1"/>
            <p:nvPr/>
          </p:nvSpPr>
          <p:spPr>
            <a:xfrm>
              <a:off x="2060141" y="622593"/>
              <a:ext cx="8499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Smad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テキスト ボックス 48"/>
          <p:cNvSpPr txBox="1"/>
          <p:nvPr/>
        </p:nvSpPr>
        <p:spPr>
          <a:xfrm>
            <a:off x="188640" y="4481709"/>
            <a:ext cx="1749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V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" name="Group 5"/>
          <p:cNvGrpSpPr/>
          <p:nvPr/>
        </p:nvGrpSpPr>
        <p:grpSpPr>
          <a:xfrm>
            <a:off x="188640" y="6372967"/>
            <a:ext cx="2185169" cy="1602459"/>
            <a:chOff x="116632" y="2555776"/>
            <a:chExt cx="3519237" cy="2346159"/>
          </a:xfrm>
        </p:grpSpPr>
        <p:pic>
          <p:nvPicPr>
            <p:cNvPr id="51" name="Picture 4" descr="C:\Users\ImageQuant\Desktop\Sonomi\Fstl1\2. NRFB\NRFB rec Fstl1 8-12-2014\NRFB1 p-smad3\20140916_1359 p-smad3_9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6632" y="2555776"/>
              <a:ext cx="3519237" cy="23461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2" name="正方形/長方形 22"/>
            <p:cNvSpPr/>
            <p:nvPr/>
          </p:nvSpPr>
          <p:spPr>
            <a:xfrm>
              <a:off x="1954932" y="3388353"/>
              <a:ext cx="894226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テキスト ボックス 23"/>
            <p:cNvSpPr txBox="1"/>
            <p:nvPr/>
          </p:nvSpPr>
          <p:spPr>
            <a:xfrm>
              <a:off x="1837341" y="3011347"/>
              <a:ext cx="8499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Smad3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Group 7"/>
          <p:cNvGrpSpPr/>
          <p:nvPr/>
        </p:nvGrpSpPr>
        <p:grpSpPr>
          <a:xfrm>
            <a:off x="2401838" y="6379067"/>
            <a:ext cx="2403686" cy="1602459"/>
            <a:chOff x="3228269" y="2305844"/>
            <a:chExt cx="2908460" cy="1938975"/>
          </a:xfrm>
        </p:grpSpPr>
        <p:pic>
          <p:nvPicPr>
            <p:cNvPr id="55" name="Picture 5" descr="C:\Users\ImageQuant\Desktop\Sonomi\Fstl1\2. NRFB\NRFB rec Fstl1 8-12-2014\NRFB1 t-smad3\NRFB1 t-smad3 20140917_1403_11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28269" y="2305844"/>
              <a:ext cx="2908460" cy="19389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6" name="正方形/長方形 22"/>
            <p:cNvSpPr/>
            <p:nvPr/>
          </p:nvSpPr>
          <p:spPr>
            <a:xfrm>
              <a:off x="4787727" y="2940216"/>
              <a:ext cx="739030" cy="183184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テキスト ボックス 23"/>
            <p:cNvSpPr txBox="1"/>
            <p:nvPr/>
          </p:nvSpPr>
          <p:spPr>
            <a:xfrm>
              <a:off x="4642294" y="2670032"/>
              <a:ext cx="934904" cy="2289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Smad3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626192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0192384"/>
              </p:ext>
            </p:extLst>
          </p:nvPr>
        </p:nvGraphicFramePr>
        <p:xfrm>
          <a:off x="332656" y="395536"/>
          <a:ext cx="6120682" cy="648072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7083"/>
                <a:gridCol w="994334"/>
                <a:gridCol w="883853"/>
                <a:gridCol w="883853"/>
                <a:gridCol w="883853"/>
                <a:gridCol w="883853"/>
                <a:gridCol w="883853"/>
              </a:tblGrid>
              <a:tr h="26831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igure EV. 3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fold increase of p-Smad 2/Smad 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WT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820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970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.303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.525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fKO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03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234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12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104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480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941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365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fold increase of p-Smad 3/Smad 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WT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171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030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68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8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fKO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27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8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034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375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68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57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3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6831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igure EV. 3B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fold increase of p-Smad 2/Smad 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rec Fstl1(-)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F-</a:t>
                      </a:r>
                      <a:r>
                        <a:rPr lang="el-GR" sz="1100" u="none" strike="noStrike">
                          <a:effectLst/>
                        </a:rPr>
                        <a:t>β1</a:t>
                      </a:r>
                      <a:endParaRPr lang="el-G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376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707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91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rec Fstl1(+)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37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12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92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F-</a:t>
                      </a:r>
                      <a:r>
                        <a:rPr lang="el-GR" sz="1100" u="none" strike="noStrike">
                          <a:effectLst/>
                        </a:rPr>
                        <a:t>β1</a:t>
                      </a:r>
                      <a:endParaRPr lang="el-G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266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668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291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fold increase of p-Smad 3/Smad 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rec Fstl1(-)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F-</a:t>
                      </a:r>
                      <a:r>
                        <a:rPr lang="el-GR" sz="1100" u="none" strike="noStrike">
                          <a:effectLst/>
                        </a:rPr>
                        <a:t>β1</a:t>
                      </a:r>
                      <a:endParaRPr lang="el-G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450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823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421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rec Fstl1(+)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3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46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00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67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F-</a:t>
                      </a:r>
                      <a:r>
                        <a:rPr lang="el-GR" sz="1100" u="none" strike="noStrike">
                          <a:effectLst/>
                        </a:rPr>
                        <a:t>β1</a:t>
                      </a:r>
                      <a:endParaRPr lang="el-G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.86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723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.8706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325206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145</Words>
  <Application>Microsoft Office PowerPoint</Application>
  <PresentationFormat>On-screen Show (4:3)</PresentationFormat>
  <Paragraphs>9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ＭＳ Ｐゴシック</vt:lpstr>
      <vt:lpstr>Arial</vt:lpstr>
      <vt:lpstr>Calibri</vt:lpstr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88</cp:revision>
  <dcterms:modified xsi:type="dcterms:W3CDTF">2016-04-22T18:43:18Z</dcterms:modified>
</cp:coreProperties>
</file>